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notesMasterIdLst>
    <p:notesMasterId r:id="rId4"/>
  </p:notesMasterIdLst>
  <p:sldIdLst>
    <p:sldId id="259" r:id="rId2"/>
    <p:sldId id="258" r:id="rId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4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5040" y="82"/>
      </p:cViewPr>
      <p:guideLst>
        <p:guide orient="horz" pos="55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moakifujii\Desktop\HN00213337\B2MsgRNA3_PBMC\crispresso2_B2M\CRISPRessoWGS_on_B2MsgRNA3_PBMC_Crisoresso\SAMPLES_QUANTIFICATION_Cas9_B2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moakifujii\Desktop\HN00213337\TRACsgRNA5_PBMC\offtarget_TRAC_Cas9\crispresso2_TRAC\CRISPRessoWGS_on_TRACsgRNA5_PBMC_TRAC_Crisoresso\Cas9&#65343;TRAC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2617705613991"/>
          <c:y val="0.13668253968253968"/>
          <c:w val="0.92673242612418483"/>
          <c:h val="0.8136293650793650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Sheet2!$C$15:$CM$15</c:f>
              <c:strCache>
                <c:ptCount val="89"/>
                <c:pt idx="1">
                  <c:v>OT1</c:v>
                </c:pt>
                <c:pt idx="2">
                  <c:v>OT2</c:v>
                </c:pt>
                <c:pt idx="3">
                  <c:v>OT3</c:v>
                </c:pt>
                <c:pt idx="4">
                  <c:v>OT4</c:v>
                </c:pt>
                <c:pt idx="5">
                  <c:v>OT5</c:v>
                </c:pt>
                <c:pt idx="6">
                  <c:v>OT6</c:v>
                </c:pt>
                <c:pt idx="7">
                  <c:v>OT7</c:v>
                </c:pt>
                <c:pt idx="8">
                  <c:v>OT8</c:v>
                </c:pt>
                <c:pt idx="9">
                  <c:v>OT9</c:v>
                </c:pt>
                <c:pt idx="10">
                  <c:v>OT10</c:v>
                </c:pt>
                <c:pt idx="11">
                  <c:v>OT11</c:v>
                </c:pt>
                <c:pt idx="12">
                  <c:v>OT12</c:v>
                </c:pt>
                <c:pt idx="13">
                  <c:v>OT13</c:v>
                </c:pt>
                <c:pt idx="14">
                  <c:v>OT14</c:v>
                </c:pt>
                <c:pt idx="15">
                  <c:v>OT15</c:v>
                </c:pt>
                <c:pt idx="16">
                  <c:v>OT16</c:v>
                </c:pt>
                <c:pt idx="17">
                  <c:v>OT17</c:v>
                </c:pt>
                <c:pt idx="18">
                  <c:v>OT18</c:v>
                </c:pt>
                <c:pt idx="19">
                  <c:v>OT19</c:v>
                </c:pt>
                <c:pt idx="20">
                  <c:v>OT20</c:v>
                </c:pt>
                <c:pt idx="21">
                  <c:v>OT21</c:v>
                </c:pt>
                <c:pt idx="22">
                  <c:v>OT22</c:v>
                </c:pt>
                <c:pt idx="23">
                  <c:v>OT23</c:v>
                </c:pt>
                <c:pt idx="24">
                  <c:v>OT24</c:v>
                </c:pt>
                <c:pt idx="25">
                  <c:v>OT25</c:v>
                </c:pt>
                <c:pt idx="26">
                  <c:v>OT26</c:v>
                </c:pt>
                <c:pt idx="27">
                  <c:v>OT27</c:v>
                </c:pt>
                <c:pt idx="28">
                  <c:v>OT28</c:v>
                </c:pt>
                <c:pt idx="29">
                  <c:v>OT29</c:v>
                </c:pt>
                <c:pt idx="30">
                  <c:v>OT30</c:v>
                </c:pt>
                <c:pt idx="31">
                  <c:v>OT31</c:v>
                </c:pt>
                <c:pt idx="32">
                  <c:v>OT32</c:v>
                </c:pt>
                <c:pt idx="33">
                  <c:v>OT33</c:v>
                </c:pt>
                <c:pt idx="34">
                  <c:v>OT34</c:v>
                </c:pt>
                <c:pt idx="35">
                  <c:v>OT35</c:v>
                </c:pt>
                <c:pt idx="36">
                  <c:v>OT36</c:v>
                </c:pt>
                <c:pt idx="37">
                  <c:v>OT37</c:v>
                </c:pt>
                <c:pt idx="38">
                  <c:v>OT38</c:v>
                </c:pt>
                <c:pt idx="39">
                  <c:v>OT39</c:v>
                </c:pt>
                <c:pt idx="40">
                  <c:v>OT40</c:v>
                </c:pt>
                <c:pt idx="41">
                  <c:v>OT41</c:v>
                </c:pt>
                <c:pt idx="42">
                  <c:v>OT42</c:v>
                </c:pt>
                <c:pt idx="43">
                  <c:v>OT43</c:v>
                </c:pt>
                <c:pt idx="44">
                  <c:v>OT44</c:v>
                </c:pt>
                <c:pt idx="45">
                  <c:v>OT45</c:v>
                </c:pt>
                <c:pt idx="46">
                  <c:v>OT46</c:v>
                </c:pt>
                <c:pt idx="47">
                  <c:v>OT47</c:v>
                </c:pt>
                <c:pt idx="48">
                  <c:v>OT48</c:v>
                </c:pt>
                <c:pt idx="49">
                  <c:v>OT49</c:v>
                </c:pt>
                <c:pt idx="50">
                  <c:v>OT50</c:v>
                </c:pt>
                <c:pt idx="51">
                  <c:v>OT51</c:v>
                </c:pt>
                <c:pt idx="52">
                  <c:v>OT52</c:v>
                </c:pt>
                <c:pt idx="53">
                  <c:v>OT53</c:v>
                </c:pt>
                <c:pt idx="54">
                  <c:v>OT54</c:v>
                </c:pt>
                <c:pt idx="55">
                  <c:v>OT55</c:v>
                </c:pt>
                <c:pt idx="56">
                  <c:v>OT56</c:v>
                </c:pt>
                <c:pt idx="57">
                  <c:v>OT57</c:v>
                </c:pt>
                <c:pt idx="58">
                  <c:v>OT58</c:v>
                </c:pt>
                <c:pt idx="59">
                  <c:v>OT59</c:v>
                </c:pt>
                <c:pt idx="60">
                  <c:v>OT60</c:v>
                </c:pt>
                <c:pt idx="61">
                  <c:v>OT61</c:v>
                </c:pt>
                <c:pt idx="62">
                  <c:v>OT62</c:v>
                </c:pt>
                <c:pt idx="63">
                  <c:v>OT63</c:v>
                </c:pt>
                <c:pt idx="64">
                  <c:v>OT64</c:v>
                </c:pt>
                <c:pt idx="65">
                  <c:v>OT65</c:v>
                </c:pt>
                <c:pt idx="66">
                  <c:v>OT66</c:v>
                </c:pt>
                <c:pt idx="67">
                  <c:v>OT67</c:v>
                </c:pt>
                <c:pt idx="68">
                  <c:v>OT68</c:v>
                </c:pt>
                <c:pt idx="69">
                  <c:v>OT69</c:v>
                </c:pt>
                <c:pt idx="70">
                  <c:v>OT70</c:v>
                </c:pt>
                <c:pt idx="71">
                  <c:v>OT71</c:v>
                </c:pt>
                <c:pt idx="72">
                  <c:v>OT72</c:v>
                </c:pt>
                <c:pt idx="73">
                  <c:v>OT73</c:v>
                </c:pt>
                <c:pt idx="74">
                  <c:v>OT74</c:v>
                </c:pt>
                <c:pt idx="75">
                  <c:v>OT75</c:v>
                </c:pt>
                <c:pt idx="76">
                  <c:v>OT76</c:v>
                </c:pt>
                <c:pt idx="77">
                  <c:v>OT77</c:v>
                </c:pt>
                <c:pt idx="78">
                  <c:v>OT78</c:v>
                </c:pt>
                <c:pt idx="79">
                  <c:v>OT79</c:v>
                </c:pt>
                <c:pt idx="80">
                  <c:v>OT80</c:v>
                </c:pt>
                <c:pt idx="81">
                  <c:v>OT81</c:v>
                </c:pt>
                <c:pt idx="82">
                  <c:v>OT82</c:v>
                </c:pt>
                <c:pt idx="83">
                  <c:v>OT83</c:v>
                </c:pt>
                <c:pt idx="84">
                  <c:v>OT84</c:v>
                </c:pt>
                <c:pt idx="85">
                  <c:v>OT85</c:v>
                </c:pt>
                <c:pt idx="86">
                  <c:v>OT86</c:v>
                </c:pt>
                <c:pt idx="87">
                  <c:v>OT87</c:v>
                </c:pt>
                <c:pt idx="88">
                  <c:v>OT88</c:v>
                </c:pt>
              </c:strCache>
            </c:strRef>
          </c:xVal>
          <c:yVal>
            <c:numRef>
              <c:f>Sheet2!$C$16:$CM$16</c:f>
              <c:numCache>
                <c:formatCode>General</c:formatCode>
                <c:ptCount val="89"/>
                <c:pt idx="0">
                  <c:v>0.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6.72890216579536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21253985122210414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.7894002789400279E-2</c:v>
                </c:pt>
                <c:pt idx="25">
                  <c:v>0</c:v>
                </c:pt>
                <c:pt idx="26">
                  <c:v>0</c:v>
                </c:pt>
                <c:pt idx="27">
                  <c:v>-0.4273504273504273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97.516556291390728</c:v>
                </c:pt>
                <c:pt idx="33">
                  <c:v>-0.27548209366391185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.14150943396226415</c:v>
                </c:pt>
                <c:pt idx="38">
                  <c:v>0</c:v>
                </c:pt>
                <c:pt idx="39">
                  <c:v>-1.0743446497636441E-2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.1834862385321101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-3.8979972090338877E-4</c:v>
                </c:pt>
                <c:pt idx="55">
                  <c:v>0</c:v>
                </c:pt>
                <c:pt idx="56">
                  <c:v>-3.7090212969609931E-2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3.341129301703976E-2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-6.978367062107467E-2</c:v>
                </c:pt>
                <c:pt idx="71">
                  <c:v>6.5445026178010471E-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2.7078256160303276E-2</c:v>
                </c:pt>
                <c:pt idx="76">
                  <c:v>0</c:v>
                </c:pt>
                <c:pt idx="77">
                  <c:v>0</c:v>
                </c:pt>
                <c:pt idx="78">
                  <c:v>0.13850415512465375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1.8662519440124417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417-4256-97D3-5C3B7E1B31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2902480"/>
        <c:axId val="252904192"/>
      </c:scatterChart>
      <c:valAx>
        <c:axId val="2529024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2904192"/>
        <c:crosses val="autoZero"/>
        <c:crossBetween val="midCat"/>
      </c:valAx>
      <c:valAx>
        <c:axId val="252904192"/>
        <c:scaling>
          <c:orientation val="minMax"/>
          <c:max val="100"/>
          <c:min val="-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2902480"/>
        <c:crosses val="autoZero"/>
        <c:crossBetween val="midCat"/>
        <c:majorUnit val="10"/>
        <c:min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82465637180851"/>
          <c:y val="0.13103174603174603"/>
          <c:w val="0.76501275200954888"/>
          <c:h val="0.7580952380952380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Sheet2!$C$9:$GE$9</c:f>
              <c:strCache>
                <c:ptCount val="185"/>
                <c:pt idx="0">
                  <c:v>OT1</c:v>
                </c:pt>
                <c:pt idx="1">
                  <c:v>OT2</c:v>
                </c:pt>
                <c:pt idx="2">
                  <c:v>OT3</c:v>
                </c:pt>
                <c:pt idx="3">
                  <c:v>OT4</c:v>
                </c:pt>
                <c:pt idx="4">
                  <c:v>OT5</c:v>
                </c:pt>
                <c:pt idx="5">
                  <c:v>OT6</c:v>
                </c:pt>
                <c:pt idx="6">
                  <c:v>OT7</c:v>
                </c:pt>
                <c:pt idx="7">
                  <c:v>OT8</c:v>
                </c:pt>
                <c:pt idx="8">
                  <c:v>OT9</c:v>
                </c:pt>
                <c:pt idx="9">
                  <c:v>OT10</c:v>
                </c:pt>
                <c:pt idx="10">
                  <c:v>OT11</c:v>
                </c:pt>
                <c:pt idx="11">
                  <c:v>OT12</c:v>
                </c:pt>
                <c:pt idx="12">
                  <c:v>OT13</c:v>
                </c:pt>
                <c:pt idx="13">
                  <c:v>OT14</c:v>
                </c:pt>
                <c:pt idx="14">
                  <c:v>OT15</c:v>
                </c:pt>
                <c:pt idx="15">
                  <c:v>OT16</c:v>
                </c:pt>
                <c:pt idx="16">
                  <c:v>OT17</c:v>
                </c:pt>
                <c:pt idx="17">
                  <c:v>OT18</c:v>
                </c:pt>
                <c:pt idx="18">
                  <c:v>OT19</c:v>
                </c:pt>
                <c:pt idx="19">
                  <c:v>OT20</c:v>
                </c:pt>
                <c:pt idx="20">
                  <c:v>OT21</c:v>
                </c:pt>
                <c:pt idx="21">
                  <c:v>OT22</c:v>
                </c:pt>
                <c:pt idx="22">
                  <c:v>OT23</c:v>
                </c:pt>
                <c:pt idx="23">
                  <c:v>OT24</c:v>
                </c:pt>
                <c:pt idx="24">
                  <c:v>OT25</c:v>
                </c:pt>
                <c:pt idx="25">
                  <c:v>OT26</c:v>
                </c:pt>
                <c:pt idx="26">
                  <c:v>OT27</c:v>
                </c:pt>
                <c:pt idx="27">
                  <c:v>OT28</c:v>
                </c:pt>
                <c:pt idx="28">
                  <c:v>OT29</c:v>
                </c:pt>
                <c:pt idx="29">
                  <c:v>OT30</c:v>
                </c:pt>
                <c:pt idx="30">
                  <c:v>OT31</c:v>
                </c:pt>
                <c:pt idx="31">
                  <c:v>OT32</c:v>
                </c:pt>
                <c:pt idx="32">
                  <c:v>OT33</c:v>
                </c:pt>
                <c:pt idx="33">
                  <c:v>OT34</c:v>
                </c:pt>
                <c:pt idx="34">
                  <c:v>OT35</c:v>
                </c:pt>
                <c:pt idx="35">
                  <c:v>OT36</c:v>
                </c:pt>
                <c:pt idx="36">
                  <c:v>OT37</c:v>
                </c:pt>
                <c:pt idx="37">
                  <c:v>OT38</c:v>
                </c:pt>
                <c:pt idx="38">
                  <c:v>OT39</c:v>
                </c:pt>
                <c:pt idx="39">
                  <c:v>OT40</c:v>
                </c:pt>
                <c:pt idx="40">
                  <c:v>OT41</c:v>
                </c:pt>
                <c:pt idx="41">
                  <c:v>OT42</c:v>
                </c:pt>
                <c:pt idx="42">
                  <c:v>OT43</c:v>
                </c:pt>
                <c:pt idx="43">
                  <c:v>OT44</c:v>
                </c:pt>
                <c:pt idx="44">
                  <c:v>OT45</c:v>
                </c:pt>
                <c:pt idx="45">
                  <c:v>OT46</c:v>
                </c:pt>
                <c:pt idx="46">
                  <c:v>OT47</c:v>
                </c:pt>
                <c:pt idx="47">
                  <c:v>OT48</c:v>
                </c:pt>
                <c:pt idx="48">
                  <c:v>OT49</c:v>
                </c:pt>
                <c:pt idx="49">
                  <c:v>OT50</c:v>
                </c:pt>
                <c:pt idx="50">
                  <c:v>OT51</c:v>
                </c:pt>
                <c:pt idx="51">
                  <c:v>OT52</c:v>
                </c:pt>
                <c:pt idx="52">
                  <c:v>OT53</c:v>
                </c:pt>
                <c:pt idx="53">
                  <c:v>OT54</c:v>
                </c:pt>
                <c:pt idx="54">
                  <c:v>OT55</c:v>
                </c:pt>
                <c:pt idx="55">
                  <c:v>OT56</c:v>
                </c:pt>
                <c:pt idx="56">
                  <c:v>OT57</c:v>
                </c:pt>
                <c:pt idx="57">
                  <c:v>OT58</c:v>
                </c:pt>
                <c:pt idx="58">
                  <c:v>OT59</c:v>
                </c:pt>
                <c:pt idx="59">
                  <c:v>OT60</c:v>
                </c:pt>
                <c:pt idx="60">
                  <c:v>OT61</c:v>
                </c:pt>
                <c:pt idx="61">
                  <c:v>OT62</c:v>
                </c:pt>
                <c:pt idx="62">
                  <c:v>OT63</c:v>
                </c:pt>
                <c:pt idx="63">
                  <c:v>OT64</c:v>
                </c:pt>
                <c:pt idx="64">
                  <c:v>OT65</c:v>
                </c:pt>
                <c:pt idx="65">
                  <c:v>OT66</c:v>
                </c:pt>
                <c:pt idx="66">
                  <c:v>OT67</c:v>
                </c:pt>
                <c:pt idx="67">
                  <c:v>OT68</c:v>
                </c:pt>
                <c:pt idx="68">
                  <c:v>OT69</c:v>
                </c:pt>
                <c:pt idx="69">
                  <c:v>OT70</c:v>
                </c:pt>
                <c:pt idx="70">
                  <c:v>OT71</c:v>
                </c:pt>
                <c:pt idx="71">
                  <c:v>OT72</c:v>
                </c:pt>
                <c:pt idx="72">
                  <c:v>OT73</c:v>
                </c:pt>
                <c:pt idx="73">
                  <c:v>OT74</c:v>
                </c:pt>
                <c:pt idx="74">
                  <c:v>OT75</c:v>
                </c:pt>
                <c:pt idx="75">
                  <c:v>OT76</c:v>
                </c:pt>
                <c:pt idx="76">
                  <c:v>OT77</c:v>
                </c:pt>
                <c:pt idx="77">
                  <c:v>OT78</c:v>
                </c:pt>
                <c:pt idx="78">
                  <c:v>OT79</c:v>
                </c:pt>
                <c:pt idx="79">
                  <c:v>OT80</c:v>
                </c:pt>
                <c:pt idx="80">
                  <c:v>OT81</c:v>
                </c:pt>
                <c:pt idx="81">
                  <c:v>OT82</c:v>
                </c:pt>
                <c:pt idx="82">
                  <c:v>OT83</c:v>
                </c:pt>
                <c:pt idx="83">
                  <c:v>OT84</c:v>
                </c:pt>
                <c:pt idx="84">
                  <c:v>OT85</c:v>
                </c:pt>
                <c:pt idx="85">
                  <c:v>OT86</c:v>
                </c:pt>
                <c:pt idx="86">
                  <c:v>OT87</c:v>
                </c:pt>
                <c:pt idx="87">
                  <c:v>OT88</c:v>
                </c:pt>
                <c:pt idx="88">
                  <c:v>OT89</c:v>
                </c:pt>
                <c:pt idx="89">
                  <c:v>OT90</c:v>
                </c:pt>
                <c:pt idx="90">
                  <c:v>OT91</c:v>
                </c:pt>
                <c:pt idx="91">
                  <c:v>OT92</c:v>
                </c:pt>
                <c:pt idx="92">
                  <c:v>OT93</c:v>
                </c:pt>
                <c:pt idx="93">
                  <c:v>OT94</c:v>
                </c:pt>
                <c:pt idx="94">
                  <c:v>OT95</c:v>
                </c:pt>
                <c:pt idx="95">
                  <c:v>OT96</c:v>
                </c:pt>
                <c:pt idx="96">
                  <c:v>OT97</c:v>
                </c:pt>
                <c:pt idx="97">
                  <c:v>OT98</c:v>
                </c:pt>
                <c:pt idx="98">
                  <c:v>OT99</c:v>
                </c:pt>
                <c:pt idx="99">
                  <c:v>OT100</c:v>
                </c:pt>
                <c:pt idx="100">
                  <c:v>OT101</c:v>
                </c:pt>
                <c:pt idx="101">
                  <c:v>OT102</c:v>
                </c:pt>
                <c:pt idx="102">
                  <c:v>OT103</c:v>
                </c:pt>
                <c:pt idx="103">
                  <c:v>OT104</c:v>
                </c:pt>
                <c:pt idx="104">
                  <c:v>OT105</c:v>
                </c:pt>
                <c:pt idx="105">
                  <c:v>OT106</c:v>
                </c:pt>
                <c:pt idx="106">
                  <c:v>OT107</c:v>
                </c:pt>
                <c:pt idx="107">
                  <c:v>OT108</c:v>
                </c:pt>
                <c:pt idx="108">
                  <c:v>OT109</c:v>
                </c:pt>
                <c:pt idx="109">
                  <c:v>OT110</c:v>
                </c:pt>
                <c:pt idx="110">
                  <c:v>OT111</c:v>
                </c:pt>
                <c:pt idx="111">
                  <c:v>OT112</c:v>
                </c:pt>
                <c:pt idx="112">
                  <c:v>OT113</c:v>
                </c:pt>
                <c:pt idx="113">
                  <c:v>OT114</c:v>
                </c:pt>
                <c:pt idx="114">
                  <c:v>OT115</c:v>
                </c:pt>
                <c:pt idx="115">
                  <c:v>OT116</c:v>
                </c:pt>
                <c:pt idx="116">
                  <c:v>OT117</c:v>
                </c:pt>
                <c:pt idx="117">
                  <c:v>OT118</c:v>
                </c:pt>
                <c:pt idx="118">
                  <c:v>OT119</c:v>
                </c:pt>
                <c:pt idx="119">
                  <c:v>OT120</c:v>
                </c:pt>
                <c:pt idx="120">
                  <c:v>OT121</c:v>
                </c:pt>
                <c:pt idx="121">
                  <c:v>OT122</c:v>
                </c:pt>
                <c:pt idx="122">
                  <c:v>OT123</c:v>
                </c:pt>
                <c:pt idx="123">
                  <c:v>OT124</c:v>
                </c:pt>
                <c:pt idx="124">
                  <c:v>OT125</c:v>
                </c:pt>
                <c:pt idx="125">
                  <c:v>OT126</c:v>
                </c:pt>
                <c:pt idx="126">
                  <c:v>OT127</c:v>
                </c:pt>
                <c:pt idx="127">
                  <c:v>OT128</c:v>
                </c:pt>
                <c:pt idx="128">
                  <c:v>OT129</c:v>
                </c:pt>
                <c:pt idx="129">
                  <c:v>OT130</c:v>
                </c:pt>
                <c:pt idx="130">
                  <c:v>OT131</c:v>
                </c:pt>
                <c:pt idx="131">
                  <c:v>OT132</c:v>
                </c:pt>
                <c:pt idx="132">
                  <c:v>OT133</c:v>
                </c:pt>
                <c:pt idx="133">
                  <c:v>OT134</c:v>
                </c:pt>
                <c:pt idx="134">
                  <c:v>OT135</c:v>
                </c:pt>
                <c:pt idx="135">
                  <c:v>OT136</c:v>
                </c:pt>
                <c:pt idx="136">
                  <c:v>OT137</c:v>
                </c:pt>
                <c:pt idx="137">
                  <c:v>OT138</c:v>
                </c:pt>
                <c:pt idx="138">
                  <c:v>OT139</c:v>
                </c:pt>
                <c:pt idx="139">
                  <c:v>OT140</c:v>
                </c:pt>
                <c:pt idx="140">
                  <c:v>OT141</c:v>
                </c:pt>
                <c:pt idx="141">
                  <c:v>OT142</c:v>
                </c:pt>
                <c:pt idx="142">
                  <c:v>OT143</c:v>
                </c:pt>
                <c:pt idx="143">
                  <c:v>OT144</c:v>
                </c:pt>
                <c:pt idx="144">
                  <c:v>OT145</c:v>
                </c:pt>
                <c:pt idx="145">
                  <c:v>OT146</c:v>
                </c:pt>
                <c:pt idx="146">
                  <c:v>OT147</c:v>
                </c:pt>
                <c:pt idx="147">
                  <c:v>OT148</c:v>
                </c:pt>
                <c:pt idx="148">
                  <c:v>OT149</c:v>
                </c:pt>
                <c:pt idx="149">
                  <c:v>OT150</c:v>
                </c:pt>
                <c:pt idx="150">
                  <c:v>OT151</c:v>
                </c:pt>
                <c:pt idx="151">
                  <c:v>OT152</c:v>
                </c:pt>
                <c:pt idx="152">
                  <c:v>OT153</c:v>
                </c:pt>
                <c:pt idx="153">
                  <c:v>OT154</c:v>
                </c:pt>
                <c:pt idx="154">
                  <c:v>OT155</c:v>
                </c:pt>
                <c:pt idx="155">
                  <c:v>OT156</c:v>
                </c:pt>
                <c:pt idx="156">
                  <c:v>OT157</c:v>
                </c:pt>
                <c:pt idx="157">
                  <c:v>OT158</c:v>
                </c:pt>
                <c:pt idx="158">
                  <c:v>OT159</c:v>
                </c:pt>
                <c:pt idx="159">
                  <c:v>OT160</c:v>
                </c:pt>
                <c:pt idx="160">
                  <c:v>OT161</c:v>
                </c:pt>
                <c:pt idx="161">
                  <c:v>OT162</c:v>
                </c:pt>
                <c:pt idx="162">
                  <c:v>OT163</c:v>
                </c:pt>
                <c:pt idx="163">
                  <c:v>OT164</c:v>
                </c:pt>
                <c:pt idx="164">
                  <c:v>OT165</c:v>
                </c:pt>
                <c:pt idx="165">
                  <c:v>OT166</c:v>
                </c:pt>
                <c:pt idx="166">
                  <c:v>OT167</c:v>
                </c:pt>
                <c:pt idx="167">
                  <c:v>OT168</c:v>
                </c:pt>
                <c:pt idx="168">
                  <c:v>OT169</c:v>
                </c:pt>
                <c:pt idx="169">
                  <c:v>OT170</c:v>
                </c:pt>
                <c:pt idx="170">
                  <c:v>OT171</c:v>
                </c:pt>
                <c:pt idx="171">
                  <c:v>OT172</c:v>
                </c:pt>
                <c:pt idx="172">
                  <c:v>OT173</c:v>
                </c:pt>
                <c:pt idx="173">
                  <c:v>OT174</c:v>
                </c:pt>
                <c:pt idx="174">
                  <c:v>OT175</c:v>
                </c:pt>
                <c:pt idx="175">
                  <c:v>OT176</c:v>
                </c:pt>
                <c:pt idx="176">
                  <c:v>OT177</c:v>
                </c:pt>
                <c:pt idx="177">
                  <c:v>OT178</c:v>
                </c:pt>
                <c:pt idx="178">
                  <c:v>OT179</c:v>
                </c:pt>
                <c:pt idx="179">
                  <c:v>OT180</c:v>
                </c:pt>
                <c:pt idx="180">
                  <c:v>OT181</c:v>
                </c:pt>
                <c:pt idx="181">
                  <c:v>OT182</c:v>
                </c:pt>
                <c:pt idx="182">
                  <c:v>OT183</c:v>
                </c:pt>
                <c:pt idx="183">
                  <c:v>OT184</c:v>
                </c:pt>
                <c:pt idx="184">
                  <c:v>OT185</c:v>
                </c:pt>
              </c:strCache>
            </c:strRef>
          </c:xVal>
          <c:yVal>
            <c:numRef>
              <c:f>Sheet2!$C$10:$GE$10</c:f>
              <c:numCache>
                <c:formatCode>General</c:formatCode>
                <c:ptCount val="185"/>
                <c:pt idx="0">
                  <c:v>-2.2446689113355778E-2</c:v>
                </c:pt>
                <c:pt idx="1">
                  <c:v>0</c:v>
                </c:pt>
                <c:pt idx="2">
                  <c:v>0</c:v>
                </c:pt>
                <c:pt idx="3">
                  <c:v>-6.2833804586867728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-2.5113008538422903E-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.2478077297823968E-2</c:v>
                </c:pt>
                <c:pt idx="18">
                  <c:v>0</c:v>
                </c:pt>
                <c:pt idx="19">
                  <c:v>0</c:v>
                </c:pt>
                <c:pt idx="20">
                  <c:v>-4.084967320261438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.10964912280701754</c:v>
                </c:pt>
                <c:pt idx="28">
                  <c:v>3.6461595216238651E-3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-0.10893246187363835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2.3837074196786413E-3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93.837614264647911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3.0422878004259205E-2</c:v>
                </c:pt>
                <c:pt idx="132">
                  <c:v>0.32530904359141183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.11723329425556858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4.5977011494252871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-1.9580967299784608E-2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.10995052226498075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CC3-43FE-B802-B0244B8C53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51133551"/>
        <c:axId val="1851149423"/>
      </c:scatterChart>
      <c:valAx>
        <c:axId val="1851133551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51149423"/>
        <c:crosses val="autoZero"/>
        <c:crossBetween val="midCat"/>
      </c:valAx>
      <c:valAx>
        <c:axId val="1851149423"/>
        <c:scaling>
          <c:orientation val="minMax"/>
          <c:max val="100"/>
          <c:min val="-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51133551"/>
        <c:crosses val="autoZero"/>
        <c:crossBetween val="midCat"/>
        <c:majorUnit val="10"/>
        <c:min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643" y="1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/>
          <a:lstStyle>
            <a:lvl1pPr algn="r">
              <a:defRPr sz="1200"/>
            </a:lvl1pPr>
          </a:lstStyle>
          <a:p>
            <a:fld id="{8FD67C80-9D5C-2D40-B990-1FD2EA4B36CF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12" tIns="45656" rIns="91312" bIns="4565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085" y="4777027"/>
            <a:ext cx="5437506" cy="3908187"/>
          </a:xfrm>
          <a:prstGeom prst="rect">
            <a:avLst/>
          </a:prstGeom>
        </p:spPr>
        <p:txBody>
          <a:bodyPr vert="horz" lIns="91312" tIns="45656" rIns="91312" bIns="4565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800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643" y="9428800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 anchor="b"/>
          <a:lstStyle>
            <a:lvl1pPr algn="r">
              <a:defRPr sz="1200"/>
            </a:lvl1pPr>
          </a:lstStyle>
          <a:p>
            <a:fld id="{7B3CA298-40B8-5C4E-BAF9-DB9171F080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5495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580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472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23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119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8461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2254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869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3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24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460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309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68BFA-348F-446D-B950-B9C17A1FAD77}" type="datetimeFigureOut">
              <a:rPr kumimoji="1" lang="ja-JP" altLang="en-US" smtClean="0"/>
              <a:t>2024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BF9C9-8E46-4C43-B573-D95091574B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22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CA8366D-5F93-42AD-A9B2-1247C96CE901}"/>
              </a:ext>
            </a:extLst>
          </p:cNvPr>
          <p:cNvSpPr txBox="1"/>
          <p:nvPr/>
        </p:nvSpPr>
        <p:spPr>
          <a:xfrm>
            <a:off x="0" y="-3059"/>
            <a:ext cx="1585690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1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sz="2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FB32D9B-57CA-43D0-9CDE-9AB1A53F90B5}"/>
              </a:ext>
            </a:extLst>
          </p:cNvPr>
          <p:cNvSpPr txBox="1"/>
          <p:nvPr/>
        </p:nvSpPr>
        <p:spPr>
          <a:xfrm>
            <a:off x="494377" y="194454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0</a:t>
            </a:r>
            <a:endParaRPr kumimoji="1" lang="ja-JP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B07C446B-B3FA-48CB-821E-B2C37ABB09E9}"/>
              </a:ext>
            </a:extLst>
          </p:cNvPr>
          <p:cNvCxnSpPr>
            <a:cxnSpLocks/>
          </p:cNvCxnSpPr>
          <p:nvPr/>
        </p:nvCxnSpPr>
        <p:spPr>
          <a:xfrm>
            <a:off x="721362" y="1906350"/>
            <a:ext cx="528319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BCF8637A-69E4-4A02-B0FF-5DC677BFAD3C}"/>
              </a:ext>
            </a:extLst>
          </p:cNvPr>
          <p:cNvGrpSpPr/>
          <p:nvPr/>
        </p:nvGrpSpPr>
        <p:grpSpPr>
          <a:xfrm>
            <a:off x="488198" y="1407221"/>
            <a:ext cx="490067" cy="396606"/>
            <a:chOff x="2643364" y="3909038"/>
            <a:chExt cx="639211" cy="644698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D5C2ECEF-8FE2-4F8A-AF1C-19CD83DA9F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 rot="5066667">
              <a:off x="2657482" y="4196319"/>
              <a:ext cx="365927" cy="348907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1869E7D4-E0F2-499F-A76F-464AEA732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 rot="5066667">
              <a:off x="2634854" y="3975527"/>
              <a:ext cx="365927" cy="348907"/>
            </a:xfrm>
            <a:prstGeom prst="rect">
              <a:avLst/>
            </a:prstGeom>
          </p:spPr>
        </p:pic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85B51AC4-F02A-46C9-B8BE-BE85F62D5A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 rot="5066667">
              <a:off x="2925158" y="3917548"/>
              <a:ext cx="365927" cy="348907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2E8EA929-09AA-4670-A305-90FBF7023A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 rot="5066667">
              <a:off x="2871457" y="4152536"/>
              <a:ext cx="365927" cy="348907"/>
            </a:xfrm>
            <a:prstGeom prst="rect">
              <a:avLst/>
            </a:prstGeom>
          </p:spPr>
        </p:pic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93A9C95-C2DD-4467-B888-AE40DF31B152}"/>
              </a:ext>
            </a:extLst>
          </p:cNvPr>
          <p:cNvSpPr txBox="1"/>
          <p:nvPr/>
        </p:nvSpPr>
        <p:spPr>
          <a:xfrm>
            <a:off x="2736431" y="194454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3</a:t>
            </a:r>
            <a:endParaRPr kumimoji="1" lang="ja-JP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27" name="図 26">
            <a:extLst>
              <a:ext uri="{FF2B5EF4-FFF2-40B4-BE49-F238E27FC236}">
                <a16:creationId xmlns:a16="http://schemas.microsoft.com/office/drawing/2014/main" id="{0DC89443-28F3-4FC6-B11B-818E984974D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3389" y="1173392"/>
            <a:ext cx="448974" cy="624565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C5F45D7-7585-45EF-8ACF-C4272D2B0402}"/>
              </a:ext>
            </a:extLst>
          </p:cNvPr>
          <p:cNvSpPr txBox="1"/>
          <p:nvPr/>
        </p:nvSpPr>
        <p:spPr>
          <a:xfrm>
            <a:off x="470088" y="1209273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37AF53C-D7B1-41DD-A769-9F65683D5D4A}"/>
              </a:ext>
            </a:extLst>
          </p:cNvPr>
          <p:cNvSpPr txBox="1"/>
          <p:nvPr/>
        </p:nvSpPr>
        <p:spPr>
          <a:xfrm>
            <a:off x="5142932" y="1232916"/>
            <a:ext cx="11428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isruption rat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l viability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ve cell number 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A215E840-C886-48CA-9FA3-B5C8E4691B98}"/>
              </a:ext>
            </a:extLst>
          </p:cNvPr>
          <p:cNvCxnSpPr/>
          <p:nvPr/>
        </p:nvCxnSpPr>
        <p:spPr>
          <a:xfrm>
            <a:off x="733232" y="1816815"/>
            <a:ext cx="0" cy="17907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070D8F83-D709-4024-A0DE-00D4C89F1AD7}"/>
              </a:ext>
            </a:extLst>
          </p:cNvPr>
          <p:cNvCxnSpPr/>
          <p:nvPr/>
        </p:nvCxnSpPr>
        <p:spPr>
          <a:xfrm>
            <a:off x="2938082" y="1816815"/>
            <a:ext cx="0" cy="17907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97BD3016-F8C0-4A84-93F9-DE2BAC927327}"/>
              </a:ext>
            </a:extLst>
          </p:cNvPr>
          <p:cNvCxnSpPr/>
          <p:nvPr/>
        </p:nvCxnSpPr>
        <p:spPr>
          <a:xfrm>
            <a:off x="5998652" y="1816815"/>
            <a:ext cx="0" cy="17907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F3EB26C-B0D8-4AE6-98EF-3458C3912D59}"/>
              </a:ext>
            </a:extLst>
          </p:cNvPr>
          <p:cNvSpPr txBox="1"/>
          <p:nvPr/>
        </p:nvSpPr>
        <p:spPr>
          <a:xfrm>
            <a:off x="5818475" y="194454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7</a:t>
            </a:r>
            <a:endParaRPr kumimoji="1" lang="ja-JP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5F13F18-7DF0-415A-8632-F8C43ACA9594}"/>
              </a:ext>
            </a:extLst>
          </p:cNvPr>
          <p:cNvSpPr/>
          <p:nvPr/>
        </p:nvSpPr>
        <p:spPr>
          <a:xfrm>
            <a:off x="690253" y="2144422"/>
            <a:ext cx="2230898" cy="19129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KT3, </a:t>
            </a:r>
            <a:r>
              <a:rPr kumimoji="1" lang="en-US" altLang="ja-JP" sz="8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ronectin</a:t>
            </a:r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IL2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E0587ACF-D822-4886-A97E-FC96E4203FC8}"/>
              </a:ext>
            </a:extLst>
          </p:cNvPr>
          <p:cNvSpPr/>
          <p:nvPr/>
        </p:nvSpPr>
        <p:spPr>
          <a:xfrm>
            <a:off x="2969323" y="2144992"/>
            <a:ext cx="3029319" cy="19129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2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0E9B57D-EEED-4EA3-8E90-3A98FC54EF9E}"/>
              </a:ext>
            </a:extLst>
          </p:cNvPr>
          <p:cNvSpPr txBox="1"/>
          <p:nvPr/>
        </p:nvSpPr>
        <p:spPr>
          <a:xfrm>
            <a:off x="2329839" y="861564"/>
            <a:ext cx="15552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Electroporation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s3-Cascade mRNA, crRN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7337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CA8366D-5F93-42AD-A9B2-1247C96CE901}"/>
              </a:ext>
            </a:extLst>
          </p:cNvPr>
          <p:cNvSpPr txBox="1"/>
          <p:nvPr/>
        </p:nvSpPr>
        <p:spPr>
          <a:xfrm>
            <a:off x="0" y="-3059"/>
            <a:ext cx="1585690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1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2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986A74E-D1DC-3094-2702-BC462D1D57F1}"/>
              </a:ext>
            </a:extLst>
          </p:cNvPr>
          <p:cNvSpPr txBox="1"/>
          <p:nvPr/>
        </p:nvSpPr>
        <p:spPr>
          <a:xfrm>
            <a:off x="103265" y="277854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A766C19-7AC7-CE89-19B3-EE8464A841D1}"/>
              </a:ext>
            </a:extLst>
          </p:cNvPr>
          <p:cNvSpPr txBox="1"/>
          <p:nvPr/>
        </p:nvSpPr>
        <p:spPr>
          <a:xfrm>
            <a:off x="103265" y="596918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17091FD-477D-22A8-ADA9-262997762F7A}"/>
              </a:ext>
            </a:extLst>
          </p:cNvPr>
          <p:cNvSpPr txBox="1"/>
          <p:nvPr/>
        </p:nvSpPr>
        <p:spPr>
          <a:xfrm>
            <a:off x="743961" y="6104037"/>
            <a:ext cx="139781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6: 138856234-138856256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F4AFE63-F081-639C-3E34-35BC3061E544}"/>
              </a:ext>
            </a:extLst>
          </p:cNvPr>
          <p:cNvSpPr txBox="1"/>
          <p:nvPr/>
        </p:nvSpPr>
        <p:spPr>
          <a:xfrm>
            <a:off x="743960" y="2909147"/>
            <a:ext cx="13401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14: 89773988-89774011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7" name="図 156">
            <a:extLst>
              <a:ext uri="{FF2B5EF4-FFF2-40B4-BE49-F238E27FC236}">
                <a16:creationId xmlns:a16="http://schemas.microsoft.com/office/drawing/2014/main" id="{BAD8D74C-BFB0-4A56-9833-B19BB3117C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4" t="12352" r="1105" b="5398"/>
          <a:stretch/>
        </p:blipFill>
        <p:spPr>
          <a:xfrm>
            <a:off x="777605" y="6309464"/>
            <a:ext cx="5999499" cy="2781299"/>
          </a:xfrm>
          <a:prstGeom prst="rect">
            <a:avLst/>
          </a:prstGeom>
        </p:spPr>
      </p:pic>
      <p:pic>
        <p:nvPicPr>
          <p:cNvPr id="161" name="図 160">
            <a:extLst>
              <a:ext uri="{FF2B5EF4-FFF2-40B4-BE49-F238E27FC236}">
                <a16:creationId xmlns:a16="http://schemas.microsoft.com/office/drawing/2014/main" id="{C24D2F0F-ECEF-4612-9B17-5F49DF7DC1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16" t="13214" r="1076" b="3869"/>
          <a:stretch/>
        </p:blipFill>
        <p:spPr>
          <a:xfrm>
            <a:off x="761983" y="3118823"/>
            <a:ext cx="5999499" cy="2639062"/>
          </a:xfrm>
          <a:prstGeom prst="rect">
            <a:avLst/>
          </a:prstGeom>
        </p:spPr>
      </p:pic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483C180A-DC30-4441-ACBD-2771E350C126}"/>
              </a:ext>
            </a:extLst>
          </p:cNvPr>
          <p:cNvSpPr txBox="1"/>
          <p:nvPr/>
        </p:nvSpPr>
        <p:spPr>
          <a:xfrm>
            <a:off x="10796" y="3830882"/>
            <a:ext cx="879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RAC sgRNA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F3C32053-A513-43D9-87B3-5726927DF451}"/>
              </a:ext>
            </a:extLst>
          </p:cNvPr>
          <p:cNvSpPr txBox="1"/>
          <p:nvPr/>
        </p:nvSpPr>
        <p:spPr>
          <a:xfrm>
            <a:off x="153908" y="5056146"/>
            <a:ext cx="56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5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431ABA5D-9618-41BC-AE1A-267D45DBCBA3}"/>
              </a:ext>
            </a:extLst>
          </p:cNvPr>
          <p:cNvSpPr txBox="1"/>
          <p:nvPr/>
        </p:nvSpPr>
        <p:spPr>
          <a:xfrm>
            <a:off x="3614647" y="9126693"/>
            <a:ext cx="59471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ECT2L gene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5AB01CC3-A214-40BB-8127-EF2F4E9B34FE}"/>
              </a:ext>
            </a:extLst>
          </p:cNvPr>
          <p:cNvSpPr/>
          <p:nvPr/>
        </p:nvSpPr>
        <p:spPr>
          <a:xfrm>
            <a:off x="792481" y="3319224"/>
            <a:ext cx="5955030" cy="13153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/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861CE5C1-5C1B-451E-BBC6-6E30AA977A9A}"/>
              </a:ext>
            </a:extLst>
          </p:cNvPr>
          <p:cNvSpPr/>
          <p:nvPr/>
        </p:nvSpPr>
        <p:spPr>
          <a:xfrm>
            <a:off x="792481" y="4653375"/>
            <a:ext cx="5955030" cy="9902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AF0287A-771D-4589-B7FA-54F816987AE3}"/>
              </a:ext>
            </a:extLst>
          </p:cNvPr>
          <p:cNvSpPr txBox="1"/>
          <p:nvPr/>
        </p:nvSpPr>
        <p:spPr>
          <a:xfrm>
            <a:off x="10796" y="7055388"/>
            <a:ext cx="879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B2M sgRNA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3AA2C5C9-3C2B-49DD-B907-3399D27BA005}"/>
              </a:ext>
            </a:extLst>
          </p:cNvPr>
          <p:cNvSpPr txBox="1"/>
          <p:nvPr/>
        </p:nvSpPr>
        <p:spPr>
          <a:xfrm>
            <a:off x="153908" y="8280651"/>
            <a:ext cx="56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5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D8561245-CB61-465B-95A8-36867FB35C9D}"/>
              </a:ext>
            </a:extLst>
          </p:cNvPr>
          <p:cNvSpPr/>
          <p:nvPr/>
        </p:nvSpPr>
        <p:spPr>
          <a:xfrm>
            <a:off x="798197" y="6514571"/>
            <a:ext cx="5978907" cy="14209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/>
          </a:p>
        </p:txBody>
      </p:sp>
      <p:sp>
        <p:nvSpPr>
          <p:cNvPr id="180" name="正方形/長方形 179">
            <a:extLst>
              <a:ext uri="{FF2B5EF4-FFF2-40B4-BE49-F238E27FC236}">
                <a16:creationId xmlns:a16="http://schemas.microsoft.com/office/drawing/2014/main" id="{8ED52A0A-9EB2-423C-A7CF-0D4E136C256E}"/>
              </a:ext>
            </a:extLst>
          </p:cNvPr>
          <p:cNvSpPr/>
          <p:nvPr/>
        </p:nvSpPr>
        <p:spPr>
          <a:xfrm>
            <a:off x="798197" y="7954571"/>
            <a:ext cx="5978907" cy="9544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20" rIns="91441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/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571CB48-6145-40DF-AB0C-0E2DFB8751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9063416"/>
              </p:ext>
            </p:extLst>
          </p:nvPr>
        </p:nvGraphicFramePr>
        <p:xfrm>
          <a:off x="3215986" y="1104829"/>
          <a:ext cx="1726095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45F6A6C-CCD4-4C19-A121-1CF476F0BDFC}"/>
              </a:ext>
            </a:extLst>
          </p:cNvPr>
          <p:cNvSpPr txBox="1"/>
          <p:nvPr/>
        </p:nvSpPr>
        <p:spPr>
          <a:xfrm>
            <a:off x="4060870" y="1472522"/>
            <a:ext cx="45685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n target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26456D4F-7BC1-4194-80C2-022F07E3A971}"/>
              </a:ext>
            </a:extLst>
          </p:cNvPr>
          <p:cNvCxnSpPr>
            <a:cxnSpLocks/>
          </p:cNvCxnSpPr>
          <p:nvPr/>
        </p:nvCxnSpPr>
        <p:spPr>
          <a:xfrm flipH="1" flipV="1">
            <a:off x="3919473" y="1329338"/>
            <a:ext cx="141397" cy="1521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94877E43-811B-4F23-9EE0-54C5865559D9}"/>
              </a:ext>
            </a:extLst>
          </p:cNvPr>
          <p:cNvCxnSpPr>
            <a:cxnSpLocks/>
          </p:cNvCxnSpPr>
          <p:nvPr/>
        </p:nvCxnSpPr>
        <p:spPr>
          <a:xfrm flipH="1">
            <a:off x="3668390" y="2062698"/>
            <a:ext cx="2281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C9F9724-AE38-4246-879B-8673FB0DFCD2}"/>
              </a:ext>
            </a:extLst>
          </p:cNvPr>
          <p:cNvSpPr txBox="1"/>
          <p:nvPr/>
        </p:nvSpPr>
        <p:spPr>
          <a:xfrm>
            <a:off x="3935154" y="1997272"/>
            <a:ext cx="46166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ff target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D2D13450-2296-4101-BB21-B751A6B80F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0572973"/>
              </p:ext>
            </p:extLst>
          </p:nvPr>
        </p:nvGraphicFramePr>
        <p:xfrm>
          <a:off x="685472" y="1187434"/>
          <a:ext cx="1715808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267747B-FBF1-48DA-9DCE-242BF026134E}"/>
              </a:ext>
            </a:extLst>
          </p:cNvPr>
          <p:cNvSpPr txBox="1"/>
          <p:nvPr/>
        </p:nvSpPr>
        <p:spPr>
          <a:xfrm rot="16200000">
            <a:off x="64977" y="1663873"/>
            <a:ext cx="12452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justed indels (%) 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4BE548B-4F09-4D4E-9F0D-C0012F49D916}"/>
              </a:ext>
            </a:extLst>
          </p:cNvPr>
          <p:cNvSpPr txBox="1"/>
          <p:nvPr/>
        </p:nvSpPr>
        <p:spPr>
          <a:xfrm>
            <a:off x="1608037" y="1542757"/>
            <a:ext cx="45685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n target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68A9A13-BAFE-4E53-A01B-601EC478787D}"/>
              </a:ext>
            </a:extLst>
          </p:cNvPr>
          <p:cNvCxnSpPr>
            <a:cxnSpLocks/>
          </p:cNvCxnSpPr>
          <p:nvPr/>
        </p:nvCxnSpPr>
        <p:spPr>
          <a:xfrm flipH="1" flipV="1">
            <a:off x="1459176" y="1431169"/>
            <a:ext cx="141397" cy="1521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115220A8-B642-4B16-BD67-F4AB9FBF71B4}"/>
              </a:ext>
            </a:extLst>
          </p:cNvPr>
          <p:cNvCxnSpPr>
            <a:cxnSpLocks/>
          </p:cNvCxnSpPr>
          <p:nvPr/>
        </p:nvCxnSpPr>
        <p:spPr>
          <a:xfrm flipH="1">
            <a:off x="1974249" y="1940349"/>
            <a:ext cx="4162" cy="1911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A8F1D5C-C4F1-478A-8EBF-DD0B14B10A12}"/>
              </a:ext>
            </a:extLst>
          </p:cNvPr>
          <p:cNvSpPr txBox="1"/>
          <p:nvPr/>
        </p:nvSpPr>
        <p:spPr>
          <a:xfrm>
            <a:off x="1680445" y="1795203"/>
            <a:ext cx="46166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ff target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63F94D3-28AB-4CA7-800B-BEE768F341AB}"/>
              </a:ext>
            </a:extLst>
          </p:cNvPr>
          <p:cNvSpPr txBox="1"/>
          <p:nvPr/>
        </p:nvSpPr>
        <p:spPr>
          <a:xfrm>
            <a:off x="1162025" y="2295374"/>
            <a:ext cx="9797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ndidate locus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3B3DADE-F594-4A7E-B943-0388AABAEA09}"/>
              </a:ext>
            </a:extLst>
          </p:cNvPr>
          <p:cNvSpPr txBox="1"/>
          <p:nvPr/>
        </p:nvSpPr>
        <p:spPr>
          <a:xfrm>
            <a:off x="3668389" y="2301177"/>
            <a:ext cx="9797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ndidate locus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AEB8525-00B1-4D2E-9813-5D2B9AF6AA2F}"/>
              </a:ext>
            </a:extLst>
          </p:cNvPr>
          <p:cNvSpPr txBox="1"/>
          <p:nvPr/>
        </p:nvSpPr>
        <p:spPr>
          <a:xfrm>
            <a:off x="831046" y="1064095"/>
            <a:ext cx="11741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s9_TRAC sgRNA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9E27814-B0A2-4123-B975-2A55608CB541}"/>
              </a:ext>
            </a:extLst>
          </p:cNvPr>
          <p:cNvSpPr txBox="1"/>
          <p:nvPr/>
        </p:nvSpPr>
        <p:spPr>
          <a:xfrm>
            <a:off x="3362792" y="1015039"/>
            <a:ext cx="1095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as9_B2M sgRNA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8B24232-DAC0-4CA7-ABE7-E5A02FD6A9E6}"/>
              </a:ext>
            </a:extLst>
          </p:cNvPr>
          <p:cNvSpPr txBox="1"/>
          <p:nvPr/>
        </p:nvSpPr>
        <p:spPr>
          <a:xfrm>
            <a:off x="523063" y="9202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C5ED00D-0CBA-4A6D-B964-53933DB6F9AD}"/>
              </a:ext>
            </a:extLst>
          </p:cNvPr>
          <p:cNvSpPr txBox="1"/>
          <p:nvPr/>
        </p:nvSpPr>
        <p:spPr>
          <a:xfrm>
            <a:off x="2844465" y="90905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8A889D4-44F9-49A8-B238-7DECBB963555}"/>
              </a:ext>
            </a:extLst>
          </p:cNvPr>
          <p:cNvSpPr txBox="1"/>
          <p:nvPr/>
        </p:nvSpPr>
        <p:spPr>
          <a:xfrm rot="16200000">
            <a:off x="2549417" y="1600700"/>
            <a:ext cx="124528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" altLang="ja-JP" sz="8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justed indels (%) </a:t>
            </a:r>
          </a:p>
        </p:txBody>
      </p:sp>
    </p:spTree>
    <p:extLst>
      <p:ext uri="{BB962C8B-B14F-4D97-AF65-F5344CB8AC3E}">
        <p14:creationId xmlns:p14="http://schemas.microsoft.com/office/powerpoint/2010/main" val="827403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2</Words>
  <Application>Microsoft Office PowerPoint</Application>
  <PresentationFormat>A4 210 x 297 mm</PresentationFormat>
  <Paragraphs>3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4-02-16T23:13:09Z</dcterms:created>
  <dcterms:modified xsi:type="dcterms:W3CDTF">2024-06-01T04:02:07Z</dcterms:modified>
</cp:coreProperties>
</file>